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260648"/>
            <a:ext cx="4536504" cy="590690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04048" y="2163921"/>
            <a:ext cx="3744416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-expression network of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G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pecifically expressed in Group III. A and B indicate two co-expression sub-networks in Group III (comparison between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aSbS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3998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2</cp:revision>
  <dcterms:modified xsi:type="dcterms:W3CDTF">2017-10-20T00:58:38Z</dcterms:modified>
</cp:coreProperties>
</file>